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05156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31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225" autoAdjust="0"/>
    <p:restoredTop sz="94660"/>
  </p:normalViewPr>
  <p:slideViewPr>
    <p:cSldViewPr>
      <p:cViewPr varScale="1">
        <p:scale>
          <a:sx n="70" d="100"/>
          <a:sy n="70" d="100"/>
        </p:scale>
        <p:origin x="1422" y="72"/>
      </p:cViewPr>
      <p:guideLst>
        <p:guide orient="horz" pos="2160"/>
        <p:guide pos="331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88670" y="2130428"/>
            <a:ext cx="893826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7340" y="3886200"/>
            <a:ext cx="736092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381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762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144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7525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1906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6288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066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5050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623810" y="274641"/>
            <a:ext cx="236601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25780" y="274641"/>
            <a:ext cx="692277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0659" y="4406903"/>
            <a:ext cx="8938260" cy="1362075"/>
          </a:xfrm>
        </p:spPr>
        <p:txBody>
          <a:bodyPr anchor="t"/>
          <a:lstStyle>
            <a:lvl1pPr algn="l">
              <a:defRPr sz="3833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0659" y="2906713"/>
            <a:ext cx="8938260" cy="1500187"/>
          </a:xfrm>
        </p:spPr>
        <p:txBody>
          <a:bodyPr anchor="b"/>
          <a:lstStyle>
            <a:lvl1pPr marL="0" indent="0">
              <a:buNone/>
              <a:defRPr sz="1917">
                <a:solidFill>
                  <a:schemeClr val="tx1">
                    <a:tint val="75000"/>
                  </a:schemeClr>
                </a:solidFill>
              </a:defRPr>
            </a:lvl1pPr>
            <a:lvl2pPr marL="438135" indent="0">
              <a:buNone/>
              <a:defRPr sz="1725">
                <a:solidFill>
                  <a:schemeClr val="tx1">
                    <a:tint val="75000"/>
                  </a:schemeClr>
                </a:solidFill>
              </a:defRPr>
            </a:lvl2pPr>
            <a:lvl3pPr marL="876270" indent="0">
              <a:buNone/>
              <a:defRPr sz="1533">
                <a:solidFill>
                  <a:schemeClr val="tx1">
                    <a:tint val="75000"/>
                  </a:schemeClr>
                </a:solidFill>
              </a:defRPr>
            </a:lvl3pPr>
            <a:lvl4pPr marL="1314404" indent="0">
              <a:buNone/>
              <a:defRPr sz="1342">
                <a:solidFill>
                  <a:schemeClr val="tx1">
                    <a:tint val="75000"/>
                  </a:schemeClr>
                </a:solidFill>
              </a:defRPr>
            </a:lvl4pPr>
            <a:lvl5pPr marL="1752539" indent="0">
              <a:buNone/>
              <a:defRPr sz="1342">
                <a:solidFill>
                  <a:schemeClr val="tx1">
                    <a:tint val="75000"/>
                  </a:schemeClr>
                </a:solidFill>
              </a:defRPr>
            </a:lvl5pPr>
            <a:lvl6pPr marL="2190674" indent="0">
              <a:buNone/>
              <a:defRPr sz="1342">
                <a:solidFill>
                  <a:schemeClr val="tx1">
                    <a:tint val="75000"/>
                  </a:schemeClr>
                </a:solidFill>
              </a:defRPr>
            </a:lvl6pPr>
            <a:lvl7pPr marL="2628809" indent="0">
              <a:buNone/>
              <a:defRPr sz="1342">
                <a:solidFill>
                  <a:schemeClr val="tx1">
                    <a:tint val="75000"/>
                  </a:schemeClr>
                </a:solidFill>
              </a:defRPr>
            </a:lvl7pPr>
            <a:lvl8pPr marL="3066943" indent="0">
              <a:buNone/>
              <a:defRPr sz="1342">
                <a:solidFill>
                  <a:schemeClr val="tx1">
                    <a:tint val="75000"/>
                  </a:schemeClr>
                </a:solidFill>
              </a:defRPr>
            </a:lvl8pPr>
            <a:lvl9pPr marL="3505078" indent="0">
              <a:buNone/>
              <a:defRPr sz="134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25780" y="1600203"/>
            <a:ext cx="4644390" cy="4525963"/>
          </a:xfrm>
        </p:spPr>
        <p:txBody>
          <a:bodyPr/>
          <a:lstStyle>
            <a:lvl1pPr>
              <a:defRPr sz="2683"/>
            </a:lvl1pPr>
            <a:lvl2pPr>
              <a:defRPr sz="2300"/>
            </a:lvl2pPr>
            <a:lvl3pPr>
              <a:defRPr sz="1917"/>
            </a:lvl3pPr>
            <a:lvl4pPr>
              <a:defRPr sz="1725"/>
            </a:lvl4pPr>
            <a:lvl5pPr>
              <a:defRPr sz="1725"/>
            </a:lvl5pPr>
            <a:lvl6pPr>
              <a:defRPr sz="1725"/>
            </a:lvl6pPr>
            <a:lvl7pPr>
              <a:defRPr sz="1725"/>
            </a:lvl7pPr>
            <a:lvl8pPr>
              <a:defRPr sz="1725"/>
            </a:lvl8pPr>
            <a:lvl9pPr>
              <a:defRPr sz="1725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45430" y="1600203"/>
            <a:ext cx="4644390" cy="4525963"/>
          </a:xfrm>
        </p:spPr>
        <p:txBody>
          <a:bodyPr/>
          <a:lstStyle>
            <a:lvl1pPr>
              <a:defRPr sz="2683"/>
            </a:lvl1pPr>
            <a:lvl2pPr>
              <a:defRPr sz="2300"/>
            </a:lvl2pPr>
            <a:lvl3pPr>
              <a:defRPr sz="1917"/>
            </a:lvl3pPr>
            <a:lvl4pPr>
              <a:defRPr sz="1725"/>
            </a:lvl4pPr>
            <a:lvl5pPr>
              <a:defRPr sz="1725"/>
            </a:lvl5pPr>
            <a:lvl6pPr>
              <a:defRPr sz="1725"/>
            </a:lvl6pPr>
            <a:lvl7pPr>
              <a:defRPr sz="1725"/>
            </a:lvl7pPr>
            <a:lvl8pPr>
              <a:defRPr sz="1725"/>
            </a:lvl8pPr>
            <a:lvl9pPr>
              <a:defRPr sz="1725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5780" y="1535113"/>
            <a:ext cx="4646217" cy="639762"/>
          </a:xfrm>
        </p:spPr>
        <p:txBody>
          <a:bodyPr anchor="b"/>
          <a:lstStyle>
            <a:lvl1pPr marL="0" indent="0">
              <a:buNone/>
              <a:defRPr sz="2300" b="1"/>
            </a:lvl1pPr>
            <a:lvl2pPr marL="438135" indent="0">
              <a:buNone/>
              <a:defRPr sz="1917" b="1"/>
            </a:lvl2pPr>
            <a:lvl3pPr marL="876270" indent="0">
              <a:buNone/>
              <a:defRPr sz="1725" b="1"/>
            </a:lvl3pPr>
            <a:lvl4pPr marL="1314404" indent="0">
              <a:buNone/>
              <a:defRPr sz="1533" b="1"/>
            </a:lvl4pPr>
            <a:lvl5pPr marL="1752539" indent="0">
              <a:buNone/>
              <a:defRPr sz="1533" b="1"/>
            </a:lvl5pPr>
            <a:lvl6pPr marL="2190674" indent="0">
              <a:buNone/>
              <a:defRPr sz="1533" b="1"/>
            </a:lvl6pPr>
            <a:lvl7pPr marL="2628809" indent="0">
              <a:buNone/>
              <a:defRPr sz="1533" b="1"/>
            </a:lvl7pPr>
            <a:lvl8pPr marL="3066943" indent="0">
              <a:buNone/>
              <a:defRPr sz="1533" b="1"/>
            </a:lvl8pPr>
            <a:lvl9pPr marL="3505078" indent="0">
              <a:buNone/>
              <a:defRPr sz="15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5780" y="2174875"/>
            <a:ext cx="4646217" cy="3951288"/>
          </a:xfrm>
        </p:spPr>
        <p:txBody>
          <a:bodyPr/>
          <a:lstStyle>
            <a:lvl1pPr>
              <a:defRPr sz="2300"/>
            </a:lvl1pPr>
            <a:lvl2pPr>
              <a:defRPr sz="1917"/>
            </a:lvl2pPr>
            <a:lvl3pPr>
              <a:defRPr sz="1725"/>
            </a:lvl3pPr>
            <a:lvl4pPr>
              <a:defRPr sz="1533"/>
            </a:lvl4pPr>
            <a:lvl5pPr>
              <a:defRPr sz="1533"/>
            </a:lvl5pPr>
            <a:lvl6pPr>
              <a:defRPr sz="1533"/>
            </a:lvl6pPr>
            <a:lvl7pPr>
              <a:defRPr sz="1533"/>
            </a:lvl7pPr>
            <a:lvl8pPr>
              <a:defRPr sz="1533"/>
            </a:lvl8pPr>
            <a:lvl9pPr>
              <a:defRPr sz="1533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341780" y="1535113"/>
            <a:ext cx="4648042" cy="639762"/>
          </a:xfrm>
        </p:spPr>
        <p:txBody>
          <a:bodyPr anchor="b"/>
          <a:lstStyle>
            <a:lvl1pPr marL="0" indent="0">
              <a:buNone/>
              <a:defRPr sz="2300" b="1"/>
            </a:lvl1pPr>
            <a:lvl2pPr marL="438135" indent="0">
              <a:buNone/>
              <a:defRPr sz="1917" b="1"/>
            </a:lvl2pPr>
            <a:lvl3pPr marL="876270" indent="0">
              <a:buNone/>
              <a:defRPr sz="1725" b="1"/>
            </a:lvl3pPr>
            <a:lvl4pPr marL="1314404" indent="0">
              <a:buNone/>
              <a:defRPr sz="1533" b="1"/>
            </a:lvl4pPr>
            <a:lvl5pPr marL="1752539" indent="0">
              <a:buNone/>
              <a:defRPr sz="1533" b="1"/>
            </a:lvl5pPr>
            <a:lvl6pPr marL="2190674" indent="0">
              <a:buNone/>
              <a:defRPr sz="1533" b="1"/>
            </a:lvl6pPr>
            <a:lvl7pPr marL="2628809" indent="0">
              <a:buNone/>
              <a:defRPr sz="1533" b="1"/>
            </a:lvl7pPr>
            <a:lvl8pPr marL="3066943" indent="0">
              <a:buNone/>
              <a:defRPr sz="1533" b="1"/>
            </a:lvl8pPr>
            <a:lvl9pPr marL="3505078" indent="0">
              <a:buNone/>
              <a:defRPr sz="15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341780" y="2174875"/>
            <a:ext cx="4648042" cy="3951288"/>
          </a:xfrm>
        </p:spPr>
        <p:txBody>
          <a:bodyPr/>
          <a:lstStyle>
            <a:lvl1pPr>
              <a:defRPr sz="2300"/>
            </a:lvl1pPr>
            <a:lvl2pPr>
              <a:defRPr sz="1917"/>
            </a:lvl2pPr>
            <a:lvl3pPr>
              <a:defRPr sz="1725"/>
            </a:lvl3pPr>
            <a:lvl4pPr>
              <a:defRPr sz="1533"/>
            </a:lvl4pPr>
            <a:lvl5pPr>
              <a:defRPr sz="1533"/>
            </a:lvl5pPr>
            <a:lvl6pPr>
              <a:defRPr sz="1533"/>
            </a:lvl6pPr>
            <a:lvl7pPr>
              <a:defRPr sz="1533"/>
            </a:lvl7pPr>
            <a:lvl8pPr>
              <a:defRPr sz="1533"/>
            </a:lvl8pPr>
            <a:lvl9pPr>
              <a:defRPr sz="1533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5782" y="273050"/>
            <a:ext cx="3459559" cy="1162050"/>
          </a:xfrm>
        </p:spPr>
        <p:txBody>
          <a:bodyPr anchor="b"/>
          <a:lstStyle>
            <a:lvl1pPr algn="l">
              <a:defRPr sz="1917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111308" y="273053"/>
            <a:ext cx="5878513" cy="5853113"/>
          </a:xfrm>
        </p:spPr>
        <p:txBody>
          <a:bodyPr/>
          <a:lstStyle>
            <a:lvl1pPr>
              <a:defRPr sz="3067"/>
            </a:lvl1pPr>
            <a:lvl2pPr>
              <a:defRPr sz="2683"/>
            </a:lvl2pPr>
            <a:lvl3pPr>
              <a:defRPr sz="2300"/>
            </a:lvl3pPr>
            <a:lvl4pPr>
              <a:defRPr sz="1917"/>
            </a:lvl4pPr>
            <a:lvl5pPr>
              <a:defRPr sz="1917"/>
            </a:lvl5pPr>
            <a:lvl6pPr>
              <a:defRPr sz="1917"/>
            </a:lvl6pPr>
            <a:lvl7pPr>
              <a:defRPr sz="1917"/>
            </a:lvl7pPr>
            <a:lvl8pPr>
              <a:defRPr sz="1917"/>
            </a:lvl8pPr>
            <a:lvl9pPr>
              <a:defRPr sz="191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5782" y="1435103"/>
            <a:ext cx="3459559" cy="4691063"/>
          </a:xfrm>
        </p:spPr>
        <p:txBody>
          <a:bodyPr/>
          <a:lstStyle>
            <a:lvl1pPr marL="0" indent="0">
              <a:buNone/>
              <a:defRPr sz="1342"/>
            </a:lvl1pPr>
            <a:lvl2pPr marL="438135" indent="0">
              <a:buNone/>
              <a:defRPr sz="1150"/>
            </a:lvl2pPr>
            <a:lvl3pPr marL="876270" indent="0">
              <a:buNone/>
              <a:defRPr sz="958"/>
            </a:lvl3pPr>
            <a:lvl4pPr marL="1314404" indent="0">
              <a:buNone/>
              <a:defRPr sz="862"/>
            </a:lvl4pPr>
            <a:lvl5pPr marL="1752539" indent="0">
              <a:buNone/>
              <a:defRPr sz="862"/>
            </a:lvl5pPr>
            <a:lvl6pPr marL="2190674" indent="0">
              <a:buNone/>
              <a:defRPr sz="862"/>
            </a:lvl6pPr>
            <a:lvl7pPr marL="2628809" indent="0">
              <a:buNone/>
              <a:defRPr sz="862"/>
            </a:lvl7pPr>
            <a:lvl8pPr marL="3066943" indent="0">
              <a:buNone/>
              <a:defRPr sz="862"/>
            </a:lvl8pPr>
            <a:lvl9pPr marL="3505078" indent="0">
              <a:buNone/>
              <a:defRPr sz="862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61132" y="4800600"/>
            <a:ext cx="6309360" cy="566738"/>
          </a:xfrm>
        </p:spPr>
        <p:txBody>
          <a:bodyPr anchor="b"/>
          <a:lstStyle>
            <a:lvl1pPr algn="l">
              <a:defRPr sz="1917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061132" y="612775"/>
            <a:ext cx="6309360" cy="4114800"/>
          </a:xfrm>
        </p:spPr>
        <p:txBody>
          <a:bodyPr/>
          <a:lstStyle>
            <a:lvl1pPr marL="0" indent="0">
              <a:buNone/>
              <a:defRPr sz="3067"/>
            </a:lvl1pPr>
            <a:lvl2pPr marL="438135" indent="0">
              <a:buNone/>
              <a:defRPr sz="2683"/>
            </a:lvl2pPr>
            <a:lvl3pPr marL="876270" indent="0">
              <a:buNone/>
              <a:defRPr sz="2300"/>
            </a:lvl3pPr>
            <a:lvl4pPr marL="1314404" indent="0">
              <a:buNone/>
              <a:defRPr sz="1917"/>
            </a:lvl4pPr>
            <a:lvl5pPr marL="1752539" indent="0">
              <a:buNone/>
              <a:defRPr sz="1917"/>
            </a:lvl5pPr>
            <a:lvl6pPr marL="2190674" indent="0">
              <a:buNone/>
              <a:defRPr sz="1917"/>
            </a:lvl6pPr>
            <a:lvl7pPr marL="2628809" indent="0">
              <a:buNone/>
              <a:defRPr sz="1917"/>
            </a:lvl7pPr>
            <a:lvl8pPr marL="3066943" indent="0">
              <a:buNone/>
              <a:defRPr sz="1917"/>
            </a:lvl8pPr>
            <a:lvl9pPr marL="3505078" indent="0">
              <a:buNone/>
              <a:defRPr sz="1917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61132" y="5367338"/>
            <a:ext cx="6309360" cy="804862"/>
          </a:xfrm>
        </p:spPr>
        <p:txBody>
          <a:bodyPr/>
          <a:lstStyle>
            <a:lvl1pPr marL="0" indent="0">
              <a:buNone/>
              <a:defRPr sz="1342"/>
            </a:lvl1pPr>
            <a:lvl2pPr marL="438135" indent="0">
              <a:buNone/>
              <a:defRPr sz="1150"/>
            </a:lvl2pPr>
            <a:lvl3pPr marL="876270" indent="0">
              <a:buNone/>
              <a:defRPr sz="958"/>
            </a:lvl3pPr>
            <a:lvl4pPr marL="1314404" indent="0">
              <a:buNone/>
              <a:defRPr sz="862"/>
            </a:lvl4pPr>
            <a:lvl5pPr marL="1752539" indent="0">
              <a:buNone/>
              <a:defRPr sz="862"/>
            </a:lvl5pPr>
            <a:lvl6pPr marL="2190674" indent="0">
              <a:buNone/>
              <a:defRPr sz="862"/>
            </a:lvl6pPr>
            <a:lvl7pPr marL="2628809" indent="0">
              <a:buNone/>
              <a:defRPr sz="862"/>
            </a:lvl7pPr>
            <a:lvl8pPr marL="3066943" indent="0">
              <a:buNone/>
              <a:defRPr sz="862"/>
            </a:lvl8pPr>
            <a:lvl9pPr marL="3505078" indent="0">
              <a:buNone/>
              <a:defRPr sz="862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25780" y="274638"/>
            <a:ext cx="946404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5780" y="1600203"/>
            <a:ext cx="946404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25780" y="6356353"/>
            <a:ext cx="245364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92830" y="6356353"/>
            <a:ext cx="332994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536180" y="6356353"/>
            <a:ext cx="245364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76270" rtl="0" eaLnBrk="1" latinLnBrk="0" hangingPunct="1">
        <a:spcBef>
          <a:spcPct val="0"/>
        </a:spcBef>
        <a:buNone/>
        <a:defRPr sz="421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8601" indent="-328601" algn="l" defTabSz="876270" rtl="0" eaLnBrk="1" latinLnBrk="0" hangingPunct="1">
        <a:spcBef>
          <a:spcPct val="20000"/>
        </a:spcBef>
        <a:buFont typeface="Arial" pitchFamily="34" charset="0"/>
        <a:buChar char="•"/>
        <a:defRPr sz="3067" kern="1200">
          <a:solidFill>
            <a:schemeClr val="tx1"/>
          </a:solidFill>
          <a:latin typeface="+mn-lt"/>
          <a:ea typeface="+mn-ea"/>
          <a:cs typeface="+mn-cs"/>
        </a:defRPr>
      </a:lvl1pPr>
      <a:lvl2pPr marL="711969" indent="-273834" algn="l" defTabSz="876270" rtl="0" eaLnBrk="1" latinLnBrk="0" hangingPunct="1">
        <a:spcBef>
          <a:spcPct val="20000"/>
        </a:spcBef>
        <a:buFont typeface="Arial" pitchFamily="34" charset="0"/>
        <a:buChar char="–"/>
        <a:defRPr sz="2683" kern="1200">
          <a:solidFill>
            <a:schemeClr val="tx1"/>
          </a:solidFill>
          <a:latin typeface="+mn-lt"/>
          <a:ea typeface="+mn-ea"/>
          <a:cs typeface="+mn-cs"/>
        </a:defRPr>
      </a:lvl2pPr>
      <a:lvl3pPr marL="1095337" indent="-219067" algn="l" defTabSz="876270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3pPr>
      <a:lvl4pPr marL="1533472" indent="-219067" algn="l" defTabSz="876270" rtl="0" eaLnBrk="1" latinLnBrk="0" hangingPunct="1">
        <a:spcBef>
          <a:spcPct val="20000"/>
        </a:spcBef>
        <a:buFont typeface="Arial" pitchFamily="34" charset="0"/>
        <a:buChar char="–"/>
        <a:defRPr sz="1917" kern="1200">
          <a:solidFill>
            <a:schemeClr val="tx1"/>
          </a:solidFill>
          <a:latin typeface="+mn-lt"/>
          <a:ea typeface="+mn-ea"/>
          <a:cs typeface="+mn-cs"/>
        </a:defRPr>
      </a:lvl4pPr>
      <a:lvl5pPr marL="1971606" indent="-219067" algn="l" defTabSz="876270" rtl="0" eaLnBrk="1" latinLnBrk="0" hangingPunct="1">
        <a:spcBef>
          <a:spcPct val="20000"/>
        </a:spcBef>
        <a:buFont typeface="Arial" pitchFamily="34" charset="0"/>
        <a:buChar char="»"/>
        <a:defRPr sz="1917" kern="1200">
          <a:solidFill>
            <a:schemeClr val="tx1"/>
          </a:solidFill>
          <a:latin typeface="+mn-lt"/>
          <a:ea typeface="+mn-ea"/>
          <a:cs typeface="+mn-cs"/>
        </a:defRPr>
      </a:lvl5pPr>
      <a:lvl6pPr marL="2409741" indent="-219067" algn="l" defTabSz="876270" rtl="0" eaLnBrk="1" latinLnBrk="0" hangingPunct="1">
        <a:spcBef>
          <a:spcPct val="20000"/>
        </a:spcBef>
        <a:buFont typeface="Arial" pitchFamily="34" charset="0"/>
        <a:buChar char="•"/>
        <a:defRPr sz="1917" kern="1200">
          <a:solidFill>
            <a:schemeClr val="tx1"/>
          </a:solidFill>
          <a:latin typeface="+mn-lt"/>
          <a:ea typeface="+mn-ea"/>
          <a:cs typeface="+mn-cs"/>
        </a:defRPr>
      </a:lvl6pPr>
      <a:lvl7pPr marL="2847876" indent="-219067" algn="l" defTabSz="876270" rtl="0" eaLnBrk="1" latinLnBrk="0" hangingPunct="1">
        <a:spcBef>
          <a:spcPct val="20000"/>
        </a:spcBef>
        <a:buFont typeface="Arial" pitchFamily="34" charset="0"/>
        <a:buChar char="•"/>
        <a:defRPr sz="1917" kern="1200">
          <a:solidFill>
            <a:schemeClr val="tx1"/>
          </a:solidFill>
          <a:latin typeface="+mn-lt"/>
          <a:ea typeface="+mn-ea"/>
          <a:cs typeface="+mn-cs"/>
        </a:defRPr>
      </a:lvl7pPr>
      <a:lvl8pPr marL="3286011" indent="-219067" algn="l" defTabSz="876270" rtl="0" eaLnBrk="1" latinLnBrk="0" hangingPunct="1">
        <a:spcBef>
          <a:spcPct val="20000"/>
        </a:spcBef>
        <a:buFont typeface="Arial" pitchFamily="34" charset="0"/>
        <a:buChar char="•"/>
        <a:defRPr sz="1917" kern="1200">
          <a:solidFill>
            <a:schemeClr val="tx1"/>
          </a:solidFill>
          <a:latin typeface="+mn-lt"/>
          <a:ea typeface="+mn-ea"/>
          <a:cs typeface="+mn-cs"/>
        </a:defRPr>
      </a:lvl8pPr>
      <a:lvl9pPr marL="3724145" indent="-219067" algn="l" defTabSz="876270" rtl="0" eaLnBrk="1" latinLnBrk="0" hangingPunct="1">
        <a:spcBef>
          <a:spcPct val="20000"/>
        </a:spcBef>
        <a:buFont typeface="Arial" pitchFamily="34" charset="0"/>
        <a:buChar char="•"/>
        <a:defRPr sz="19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76270" rtl="0" eaLnBrk="1" latinLnBrk="0" hangingPunct="1">
        <a:defRPr sz="1725" kern="1200">
          <a:solidFill>
            <a:schemeClr val="tx1"/>
          </a:solidFill>
          <a:latin typeface="+mn-lt"/>
          <a:ea typeface="+mn-ea"/>
          <a:cs typeface="+mn-cs"/>
        </a:defRPr>
      </a:lvl1pPr>
      <a:lvl2pPr marL="438135" algn="l" defTabSz="876270" rtl="0" eaLnBrk="1" latinLnBrk="0" hangingPunct="1">
        <a:defRPr sz="1725" kern="1200">
          <a:solidFill>
            <a:schemeClr val="tx1"/>
          </a:solidFill>
          <a:latin typeface="+mn-lt"/>
          <a:ea typeface="+mn-ea"/>
          <a:cs typeface="+mn-cs"/>
        </a:defRPr>
      </a:lvl2pPr>
      <a:lvl3pPr marL="876270" algn="l" defTabSz="876270" rtl="0" eaLnBrk="1" latinLnBrk="0" hangingPunct="1">
        <a:defRPr sz="1725" kern="1200">
          <a:solidFill>
            <a:schemeClr val="tx1"/>
          </a:solidFill>
          <a:latin typeface="+mn-lt"/>
          <a:ea typeface="+mn-ea"/>
          <a:cs typeface="+mn-cs"/>
        </a:defRPr>
      </a:lvl3pPr>
      <a:lvl4pPr marL="1314404" algn="l" defTabSz="876270" rtl="0" eaLnBrk="1" latinLnBrk="0" hangingPunct="1">
        <a:defRPr sz="1725" kern="1200">
          <a:solidFill>
            <a:schemeClr val="tx1"/>
          </a:solidFill>
          <a:latin typeface="+mn-lt"/>
          <a:ea typeface="+mn-ea"/>
          <a:cs typeface="+mn-cs"/>
        </a:defRPr>
      </a:lvl4pPr>
      <a:lvl5pPr marL="1752539" algn="l" defTabSz="876270" rtl="0" eaLnBrk="1" latinLnBrk="0" hangingPunct="1">
        <a:defRPr sz="1725" kern="1200">
          <a:solidFill>
            <a:schemeClr val="tx1"/>
          </a:solidFill>
          <a:latin typeface="+mn-lt"/>
          <a:ea typeface="+mn-ea"/>
          <a:cs typeface="+mn-cs"/>
        </a:defRPr>
      </a:lvl5pPr>
      <a:lvl6pPr marL="2190674" algn="l" defTabSz="876270" rtl="0" eaLnBrk="1" latinLnBrk="0" hangingPunct="1">
        <a:defRPr sz="1725" kern="1200">
          <a:solidFill>
            <a:schemeClr val="tx1"/>
          </a:solidFill>
          <a:latin typeface="+mn-lt"/>
          <a:ea typeface="+mn-ea"/>
          <a:cs typeface="+mn-cs"/>
        </a:defRPr>
      </a:lvl6pPr>
      <a:lvl7pPr marL="2628809" algn="l" defTabSz="876270" rtl="0" eaLnBrk="1" latinLnBrk="0" hangingPunct="1">
        <a:defRPr sz="1725" kern="1200">
          <a:solidFill>
            <a:schemeClr val="tx1"/>
          </a:solidFill>
          <a:latin typeface="+mn-lt"/>
          <a:ea typeface="+mn-ea"/>
          <a:cs typeface="+mn-cs"/>
        </a:defRPr>
      </a:lvl7pPr>
      <a:lvl8pPr marL="3066943" algn="l" defTabSz="876270" rtl="0" eaLnBrk="1" latinLnBrk="0" hangingPunct="1">
        <a:defRPr sz="1725" kern="1200">
          <a:solidFill>
            <a:schemeClr val="tx1"/>
          </a:solidFill>
          <a:latin typeface="+mn-lt"/>
          <a:ea typeface="+mn-ea"/>
          <a:cs typeface="+mn-cs"/>
        </a:defRPr>
      </a:lvl8pPr>
      <a:lvl9pPr marL="3505078" algn="l" defTabSz="876270" rtl="0" eaLnBrk="1" latinLnBrk="0" hangingPunct="1">
        <a:defRPr sz="172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png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1083" y="430869"/>
            <a:ext cx="5047488" cy="2044553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590800" y="350371"/>
            <a:ext cx="71846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 1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9075" y="2536085"/>
            <a:ext cx="5047488" cy="2044552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2495319" y="2475422"/>
            <a:ext cx="71846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 2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6124" y="4661048"/>
            <a:ext cx="5047488" cy="2044552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2512736" y="4633035"/>
            <a:ext cx="71846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 3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95991" y="403767"/>
            <a:ext cx="5047853" cy="2044700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7162800" y="309260"/>
            <a:ext cx="161133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B28-Bol007795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21090" y="2433725"/>
            <a:ext cx="5267325" cy="2133600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7318599" y="2401037"/>
            <a:ext cx="15215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B28-Bol03628</a:t>
            </a: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21090" y="4600013"/>
            <a:ext cx="5267325" cy="2133600"/>
          </a:xfrm>
          <a:prstGeom prst="rect">
            <a:avLst/>
          </a:prstGeom>
        </p:spPr>
      </p:pic>
      <p:sp>
        <p:nvSpPr>
          <p:cNvPr id="17" name="Rectangle 16"/>
          <p:cNvSpPr/>
          <p:nvPr/>
        </p:nvSpPr>
        <p:spPr>
          <a:xfrm>
            <a:off x="7450498" y="4600013"/>
            <a:ext cx="161133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B28-Bol017019</a:t>
            </a:r>
          </a:p>
        </p:txBody>
      </p:sp>
    </p:spTree>
    <p:extLst>
      <p:ext uri="{BB962C8B-B14F-4D97-AF65-F5344CB8AC3E}">
        <p14:creationId xmlns:p14="http://schemas.microsoft.com/office/powerpoint/2010/main" val="39118611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400" y="228600"/>
            <a:ext cx="5267325" cy="21336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294709" y="84909"/>
            <a:ext cx="16321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B28-Bol036743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81600" y="259450"/>
            <a:ext cx="5267325" cy="2133600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7549274" y="179050"/>
            <a:ext cx="16321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B34-Bol007760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48275" y="2528032"/>
            <a:ext cx="5267325" cy="2133600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7583805" y="2438400"/>
            <a:ext cx="16321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B34-Bol036262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87528" y="4706982"/>
            <a:ext cx="5267325" cy="2133600"/>
          </a:xfrm>
          <a:prstGeom prst="rect">
            <a:avLst/>
          </a:prstGeom>
        </p:spPr>
      </p:pic>
      <p:sp>
        <p:nvSpPr>
          <p:cNvPr id="15" name="Rectangle 14"/>
          <p:cNvSpPr/>
          <p:nvPr/>
        </p:nvSpPr>
        <p:spPr>
          <a:xfrm>
            <a:off x="7512263" y="4664178"/>
            <a:ext cx="16321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B51-Bol013207</a:t>
            </a: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4800" y="4633493"/>
            <a:ext cx="5267325" cy="2133600"/>
          </a:xfrm>
          <a:prstGeom prst="rect">
            <a:avLst/>
          </a:prstGeom>
        </p:spPr>
      </p:pic>
      <p:sp>
        <p:nvSpPr>
          <p:cNvPr id="17" name="Rectangle 16"/>
          <p:cNvSpPr/>
          <p:nvPr/>
        </p:nvSpPr>
        <p:spPr>
          <a:xfrm>
            <a:off x="2453335" y="4573437"/>
            <a:ext cx="16321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B34-Bol017062</a:t>
            </a: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8400" y="2510615"/>
            <a:ext cx="5267325" cy="2133600"/>
          </a:xfrm>
          <a:prstGeom prst="rect">
            <a:avLst/>
          </a:prstGeom>
        </p:spPr>
      </p:pic>
      <p:sp>
        <p:nvSpPr>
          <p:cNvPr id="19" name="Rectangle 18"/>
          <p:cNvSpPr/>
          <p:nvPr/>
        </p:nvSpPr>
        <p:spPr>
          <a:xfrm>
            <a:off x="2498980" y="2422256"/>
            <a:ext cx="16321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B29-Bol008849</a:t>
            </a:r>
          </a:p>
        </p:txBody>
      </p:sp>
    </p:spTree>
    <p:extLst>
      <p:ext uri="{BB962C8B-B14F-4D97-AF65-F5344CB8AC3E}">
        <p14:creationId xmlns:p14="http://schemas.microsoft.com/office/powerpoint/2010/main" val="14831894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760" y="154581"/>
            <a:ext cx="5267325" cy="21336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057400" y="111036"/>
            <a:ext cx="16321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B51-Bol030761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200" y="4624254"/>
            <a:ext cx="5267325" cy="2133600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2194561" y="4580709"/>
            <a:ext cx="144142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5a-Bol039395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28131" y="145872"/>
            <a:ext cx="5267325" cy="2133600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7495541" y="104499"/>
            <a:ext cx="144142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5a-Bol026200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21600" y="2460175"/>
            <a:ext cx="5267325" cy="2133600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7586469" y="2410107"/>
            <a:ext cx="14510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5b-Bol026202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02006" y="4617731"/>
            <a:ext cx="5267325" cy="2133600"/>
          </a:xfrm>
          <a:prstGeom prst="rect">
            <a:avLst/>
          </a:prstGeom>
        </p:spPr>
      </p:pic>
      <p:sp>
        <p:nvSpPr>
          <p:cNvPr id="16" name="Rectangle 15"/>
          <p:cNvSpPr/>
          <p:nvPr/>
        </p:nvSpPr>
        <p:spPr>
          <a:xfrm>
            <a:off x="7662669" y="4593775"/>
            <a:ext cx="14510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5b-Bol026201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32811" y="2397026"/>
            <a:ext cx="5267325" cy="2133600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2151513" y="2338249"/>
            <a:ext cx="172194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B122-Bol026204</a:t>
            </a:r>
          </a:p>
        </p:txBody>
      </p:sp>
    </p:spTree>
    <p:extLst>
      <p:ext uri="{BB962C8B-B14F-4D97-AF65-F5344CB8AC3E}">
        <p14:creationId xmlns:p14="http://schemas.microsoft.com/office/powerpoint/2010/main" val="12701216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491" y="294646"/>
            <a:ext cx="5267325" cy="21336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2362200" y="237674"/>
            <a:ext cx="142058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5c-Bol030757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491" y="2470684"/>
            <a:ext cx="5267325" cy="2133600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2334891" y="2447109"/>
            <a:ext cx="211788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MOGS-OX2-Bol010993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48275" y="260507"/>
            <a:ext cx="5267325" cy="2133600"/>
          </a:xfrm>
          <a:prstGeom prst="rect">
            <a:avLst/>
          </a:prstGeom>
        </p:spPr>
      </p:pic>
      <p:sp>
        <p:nvSpPr>
          <p:cNvPr id="12" name="Rectangle 11"/>
          <p:cNvSpPr/>
          <p:nvPr/>
        </p:nvSpPr>
        <p:spPr>
          <a:xfrm>
            <a:off x="7166784" y="201395"/>
            <a:ext cx="211788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MOGS-OX5-Bol031350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22149" y="2454373"/>
            <a:ext cx="5267325" cy="2133600"/>
          </a:xfrm>
          <a:prstGeom prst="rect">
            <a:avLst/>
          </a:prstGeom>
        </p:spPr>
      </p:pic>
      <p:sp>
        <p:nvSpPr>
          <p:cNvPr id="15" name="Rectangle 14"/>
          <p:cNvSpPr/>
          <p:nvPr/>
        </p:nvSpPr>
        <p:spPr>
          <a:xfrm>
            <a:off x="7250152" y="2401371"/>
            <a:ext cx="173957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L-OH-Bol033373</a:t>
            </a: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22148" y="4610450"/>
            <a:ext cx="5267325" cy="2133600"/>
          </a:xfrm>
          <a:prstGeom prst="rect">
            <a:avLst/>
          </a:prstGeom>
        </p:spPr>
      </p:pic>
      <p:sp>
        <p:nvSpPr>
          <p:cNvPr id="17" name="Rectangle 16"/>
          <p:cNvSpPr/>
          <p:nvPr/>
        </p:nvSpPr>
        <p:spPr>
          <a:xfrm>
            <a:off x="7372064" y="4575196"/>
            <a:ext cx="17892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81F1-Bol028913</a:t>
            </a:r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2934" y="4612993"/>
            <a:ext cx="5267325" cy="2133600"/>
          </a:xfrm>
          <a:prstGeom prst="rect">
            <a:avLst/>
          </a:prstGeom>
        </p:spPr>
      </p:pic>
      <p:sp>
        <p:nvSpPr>
          <p:cNvPr id="21" name="Rectangle 20"/>
          <p:cNvSpPr/>
          <p:nvPr/>
        </p:nvSpPr>
        <p:spPr>
          <a:xfrm>
            <a:off x="2231501" y="4589786"/>
            <a:ext cx="211788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MOGS-OX5-Bol029100</a:t>
            </a:r>
          </a:p>
        </p:txBody>
      </p:sp>
    </p:spTree>
    <p:extLst>
      <p:ext uri="{BB962C8B-B14F-4D97-AF65-F5344CB8AC3E}">
        <p14:creationId xmlns:p14="http://schemas.microsoft.com/office/powerpoint/2010/main" val="18089334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200" y="152400"/>
            <a:ext cx="5267325" cy="21336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438400" y="95794"/>
            <a:ext cx="17892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81F1-Bol028914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200" y="4476206"/>
            <a:ext cx="5267325" cy="2133600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2229188" y="4444638"/>
            <a:ext cx="17892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81F1-Bol017376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22149" y="2342606"/>
            <a:ext cx="5267325" cy="2133600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7629524" y="2311038"/>
            <a:ext cx="17892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81F2-Bol014239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22148" y="4474029"/>
            <a:ext cx="5267325" cy="2133600"/>
          </a:xfrm>
          <a:prstGeom prst="rect">
            <a:avLst/>
          </a:prstGeom>
        </p:spPr>
      </p:pic>
      <p:sp>
        <p:nvSpPr>
          <p:cNvPr id="15" name="Rectangle 14"/>
          <p:cNvSpPr/>
          <p:nvPr/>
        </p:nvSpPr>
        <p:spPr>
          <a:xfrm>
            <a:off x="7629524" y="4471852"/>
            <a:ext cx="17892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81F2-Bol026044</a:t>
            </a: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85137" y="179615"/>
            <a:ext cx="5267325" cy="2133600"/>
          </a:xfrm>
          <a:prstGeom prst="rect">
            <a:avLst/>
          </a:prstGeom>
        </p:spPr>
      </p:pic>
      <p:sp>
        <p:nvSpPr>
          <p:cNvPr id="17" name="Rectangle 16"/>
          <p:cNvSpPr/>
          <p:nvPr/>
        </p:nvSpPr>
        <p:spPr>
          <a:xfrm>
            <a:off x="7629524" y="95794"/>
            <a:ext cx="17892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81F2-Bol012237</a:t>
            </a:r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52400" y="2311038"/>
            <a:ext cx="5267325" cy="2133600"/>
          </a:xfrm>
          <a:prstGeom prst="rect">
            <a:avLst/>
          </a:prstGeom>
        </p:spPr>
      </p:pic>
      <p:sp>
        <p:nvSpPr>
          <p:cNvPr id="20" name="Rectangle 19"/>
          <p:cNvSpPr/>
          <p:nvPr/>
        </p:nvSpPr>
        <p:spPr>
          <a:xfrm>
            <a:off x="2385331" y="2276923"/>
            <a:ext cx="17892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81F1-Bol017375</a:t>
            </a:r>
          </a:p>
        </p:txBody>
      </p:sp>
    </p:spTree>
    <p:extLst>
      <p:ext uri="{BB962C8B-B14F-4D97-AF65-F5344CB8AC3E}">
        <p14:creationId xmlns:p14="http://schemas.microsoft.com/office/powerpoint/2010/main" val="22970010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200" y="152400"/>
            <a:ext cx="5267325" cy="21336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438400" y="139339"/>
            <a:ext cx="177939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81F3-Bol032711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546" y="2416261"/>
            <a:ext cx="5267325" cy="2133600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2438400" y="2361467"/>
            <a:ext cx="17892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81F3-Bol028919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897" y="4648200"/>
            <a:ext cx="5267325" cy="2133600"/>
          </a:xfrm>
          <a:prstGeom prst="rect">
            <a:avLst/>
          </a:prstGeom>
        </p:spPr>
      </p:pic>
      <p:sp>
        <p:nvSpPr>
          <p:cNvPr id="12" name="Rectangle 11"/>
          <p:cNvSpPr/>
          <p:nvPr/>
        </p:nvSpPr>
        <p:spPr>
          <a:xfrm>
            <a:off x="2245632" y="4593406"/>
            <a:ext cx="17892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81F4-Bol032712</a:t>
            </a: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72062" y="2416261"/>
            <a:ext cx="5267325" cy="2133600"/>
          </a:xfrm>
          <a:prstGeom prst="rect">
            <a:avLst/>
          </a:prstGeom>
        </p:spPr>
      </p:pic>
      <p:sp>
        <p:nvSpPr>
          <p:cNvPr id="16" name="Rectangle 15"/>
          <p:cNvSpPr/>
          <p:nvPr/>
        </p:nvSpPr>
        <p:spPr>
          <a:xfrm>
            <a:off x="7398929" y="2361131"/>
            <a:ext cx="17892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81F4-Bol028918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72061" y="4648200"/>
            <a:ext cx="5267325" cy="2133600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7398929" y="4616653"/>
            <a:ext cx="16321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MT1-Bol007029</a:t>
            </a:r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72060" y="183986"/>
            <a:ext cx="5267325" cy="2133600"/>
          </a:xfrm>
          <a:prstGeom prst="rect">
            <a:avLst/>
          </a:prstGeom>
        </p:spPr>
      </p:pic>
      <p:sp>
        <p:nvSpPr>
          <p:cNvPr id="20" name="Rectangle 19"/>
          <p:cNvSpPr/>
          <p:nvPr/>
        </p:nvSpPr>
        <p:spPr>
          <a:xfrm>
            <a:off x="7434260" y="139339"/>
            <a:ext cx="17892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81F4-Bol032714</a:t>
            </a:r>
          </a:p>
        </p:txBody>
      </p:sp>
    </p:spTree>
    <p:extLst>
      <p:ext uri="{BB962C8B-B14F-4D97-AF65-F5344CB8AC3E}">
        <p14:creationId xmlns:p14="http://schemas.microsoft.com/office/powerpoint/2010/main" val="142220469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200" y="152400"/>
            <a:ext cx="5267325" cy="21336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362200" y="92816"/>
            <a:ext cx="159050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MT1-Bol020663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329545"/>
            <a:ext cx="5267325" cy="2133600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2245632" y="2348334"/>
            <a:ext cx="159050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MT2-Bol007030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81600" y="108855"/>
            <a:ext cx="5267325" cy="2133600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7649119" y="79745"/>
            <a:ext cx="161428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OP2-Bo3g052110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37418" y="2383972"/>
            <a:ext cx="5267325" cy="2133600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7613106" y="2343980"/>
            <a:ext cx="162095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OP2-Bo9g006240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1" y="4582885"/>
            <a:ext cx="5267325" cy="2133600"/>
          </a:xfrm>
          <a:prstGeom prst="rect">
            <a:avLst/>
          </a:prstGeom>
        </p:spPr>
      </p:pic>
      <p:sp>
        <p:nvSpPr>
          <p:cNvPr id="16" name="Rectangle 15"/>
          <p:cNvSpPr/>
          <p:nvPr/>
        </p:nvSpPr>
        <p:spPr>
          <a:xfrm>
            <a:off x="2128655" y="4569023"/>
            <a:ext cx="162095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OP2-Bo2g102190</a:t>
            </a:r>
          </a:p>
        </p:txBody>
      </p:sp>
      <p:sp>
        <p:nvSpPr>
          <p:cNvPr id="17" name="Rectangle 16"/>
          <p:cNvSpPr/>
          <p:nvPr/>
        </p:nvSpPr>
        <p:spPr>
          <a:xfrm>
            <a:off x="5351913" y="5791200"/>
            <a:ext cx="492669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3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lting curves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38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cosinolat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iosynthesis related genes and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ree actins of 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assica </a:t>
            </a:r>
            <a:r>
              <a:rPr lang="en-US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leracea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74658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97</TotalTime>
  <Words>63</Words>
  <Application>Microsoft Office PowerPoint</Application>
  <PresentationFormat>Custom</PresentationFormat>
  <Paragraphs>42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suf</dc:creator>
  <cp:lastModifiedBy>Windows User</cp:lastModifiedBy>
  <cp:revision>20</cp:revision>
  <dcterms:created xsi:type="dcterms:W3CDTF">2006-08-16T00:00:00Z</dcterms:created>
  <dcterms:modified xsi:type="dcterms:W3CDTF">2018-09-18T11:29:38Z</dcterms:modified>
</cp:coreProperties>
</file>